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0" r:id="rId3"/>
    <p:sldId id="261" r:id="rId4"/>
    <p:sldId id="262" r:id="rId5"/>
    <p:sldId id="263" r:id="rId6"/>
    <p:sldId id="264" r:id="rId7"/>
    <p:sldId id="265" r:id="rId8"/>
    <p:sldId id="266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91A1A"/>
    <a:srgbClr val="1A1A1A"/>
    <a:srgbClr val="141414"/>
    <a:srgbClr val="1C1D1D"/>
    <a:srgbClr val="1E1F1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7" d="100"/>
          <a:sy n="97" d="100"/>
        </p:scale>
        <p:origin x="-172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364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68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282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201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918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953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168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265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72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544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361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DE7A3-696C-904B-95B4-FC5991918981}" type="datetimeFigureOut">
              <a:rPr lang="en-US" smtClean="0"/>
              <a:t>20-09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103F9-AD57-6849-BE5D-7B53D8B0C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997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Relationship Id="rId3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Relationship Id="rId3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3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Relationship Id="rId3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1)</a:t>
            </a:r>
            <a:endParaRPr lang="en-US" sz="28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l="-74062" r="-74062"/>
          <a:stretch>
            <a:fillRect/>
          </a:stretch>
        </p:blipFill>
        <p:spPr>
          <a:xfrm>
            <a:off x="-1569296" y="1548254"/>
            <a:ext cx="8517310" cy="4577909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8873" y="1548255"/>
            <a:ext cx="3960937" cy="45779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84683" y="1490776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85555" y="1702689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12292" y="4440669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53969" y="1493043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3165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rcRect l="-75379" r="-75379"/>
          <a:stretch>
            <a:fillRect/>
          </a:stretch>
        </p:blipFill>
        <p:spPr>
          <a:xfrm>
            <a:off x="-1523314" y="1555186"/>
            <a:ext cx="8127391" cy="4469752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2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2771" y="1553626"/>
            <a:ext cx="3983981" cy="447131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11059" y="1499978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92653" y="4422265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87082" y="148384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256716" y="1749214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2156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Content Placeholder 11"/>
          <p:cNvPicPr>
            <a:picLocks noGrp="1" noChangeAspect="1"/>
          </p:cNvPicPr>
          <p:nvPr>
            <p:ph idx="1"/>
          </p:nvPr>
        </p:nvPicPr>
        <p:blipFill>
          <a:blip r:embed="rId2"/>
          <a:srcRect l="-73588" r="-73588"/>
          <a:stretch>
            <a:fillRect/>
          </a:stretch>
        </p:blipFill>
        <p:spPr>
          <a:xfrm>
            <a:off x="-1502955" y="1595158"/>
            <a:ext cx="8229600" cy="4525963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3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0042" y="1595158"/>
            <a:ext cx="3956084" cy="452848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6280" y="176761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88593" y="153327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01856" y="4422265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224031" y="1542220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23677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/>
          <a:srcRect l="-66354" r="-66354"/>
          <a:stretch>
            <a:fillRect/>
          </a:stretch>
        </p:blipFill>
        <p:spPr>
          <a:xfrm>
            <a:off x="-1389163" y="1600200"/>
            <a:ext cx="8229600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5)</a:t>
            </a:r>
            <a:endParaRPr lang="en-US" sz="28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0033" y="1600200"/>
            <a:ext cx="4024670" cy="452596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146280" y="172113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16202" y="1542473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20262" y="4394659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35700" y="1542220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11160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rcRect l="-75428" r="-75428"/>
          <a:stretch>
            <a:fillRect/>
          </a:stretch>
        </p:blipFill>
        <p:spPr>
          <a:xfrm>
            <a:off x="-1651335" y="1570063"/>
            <a:ext cx="8229600" cy="4525963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6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5375" y="1570063"/>
            <a:ext cx="4242242" cy="45259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6280" y="172113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6563" y="1505665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91420" y="4394659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58401" y="151838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74689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rcRect l="-66657" r="-66657"/>
          <a:stretch>
            <a:fillRect/>
          </a:stretch>
        </p:blipFill>
        <p:spPr>
          <a:xfrm>
            <a:off x="-1578303" y="1600200"/>
            <a:ext cx="8229600" cy="4525963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7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6092" y="1600200"/>
            <a:ext cx="4254115" cy="45259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6280" y="172113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41345" y="153327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36202" y="435785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60857" y="1545992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80159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rcRect l="-76840" r="-76840"/>
          <a:stretch>
            <a:fillRect/>
          </a:stretch>
        </p:blipFill>
        <p:spPr>
          <a:xfrm>
            <a:off x="-1668369" y="1561055"/>
            <a:ext cx="8229600" cy="4525963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8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5459" y="1566397"/>
            <a:ext cx="4094817" cy="452062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6280" y="172113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96563" y="1505665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91420" y="4385457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21579" y="1499982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55480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/>
          <a:srcRect l="-73576" r="-73576"/>
          <a:stretch>
            <a:fillRect/>
          </a:stretch>
        </p:blipFill>
        <p:spPr>
          <a:xfrm>
            <a:off x="-1677376" y="1600200"/>
            <a:ext cx="8229600" cy="4525963"/>
          </a:xfr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800" dirty="0" smtClean="0"/>
              <a:t>Denoising and MNI Boundaries (participant 9)</a:t>
            </a:r>
            <a:endParaRPr lang="en-US" sz="28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5818" y="1600200"/>
            <a:ext cx="4021038" cy="452596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46280" y="1721138"/>
            <a:ext cx="2580793" cy="276999"/>
          </a:xfrm>
          <a:prstGeom prst="rect">
            <a:avLst/>
          </a:prstGeom>
          <a:solidFill>
            <a:srgbClr val="191A1A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Distribution of Connectivity Values (r) 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0548" y="1533271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36202" y="4385457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39985" y="1536790"/>
            <a:ext cx="276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C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4149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19</TotalTime>
  <Words>144</Words>
  <Application>Microsoft Macintosh PowerPoint</Application>
  <PresentationFormat>On-screen Show (4:3)</PresentationFormat>
  <Paragraphs>40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Denoising and MNI Boundaries (participant 1)</vt:lpstr>
      <vt:lpstr>Denoising and MNI Boundaries (participant 2)</vt:lpstr>
      <vt:lpstr>Denoising and MNI Boundaries (participant 3)</vt:lpstr>
      <vt:lpstr>Denoising and MNI Boundaries (participant 5)</vt:lpstr>
      <vt:lpstr>Denoising and MNI Boundaries (participant 6)</vt:lpstr>
      <vt:lpstr>Denoising and MNI Boundaries (participant 7)</vt:lpstr>
      <vt:lpstr>Denoising and MNI Boundaries (participant 8)</vt:lpstr>
      <vt:lpstr>Denoising and MNI Boundaries (participant 9)</vt:lpstr>
    </vt:vector>
  </TitlesOfParts>
  <Company>McMaster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</dc:creator>
  <cp:lastModifiedBy>Diana</cp:lastModifiedBy>
  <cp:revision>45</cp:revision>
  <dcterms:created xsi:type="dcterms:W3CDTF">2018-10-31T17:20:26Z</dcterms:created>
  <dcterms:modified xsi:type="dcterms:W3CDTF">2020-09-02T18:21:44Z</dcterms:modified>
</cp:coreProperties>
</file>